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3" r:id="rId2"/>
  </p:sldIdLst>
  <p:sldSz cx="7559675" cy="10691813"/>
  <p:notesSz cx="6858000" cy="9947275"/>
  <p:defaultTextStyle>
    <a:defPPr>
      <a:defRPr lang="es-ES"/>
    </a:defPPr>
    <a:lvl1pPr marL="0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ª Carmen Bolarín" initials="MCB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8181"/>
    <a:srgbClr val="FFB7B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968" autoAdjust="0"/>
  </p:normalViewPr>
  <p:slideViewPr>
    <p:cSldViewPr>
      <p:cViewPr>
        <p:scale>
          <a:sx n="90" d="100"/>
          <a:sy n="90" d="100"/>
        </p:scale>
        <p:origin x="-1170" y="-66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C:\Users\Salt%20VII\Dropbox\Caracterizaci&#243;n_funcional_RNA_helicase_339\Microarray_339_Mayo'15\Listas_genes_FC1,5_FC2_pv0.05_conosinFDR\MapMan\Grafica_number_genes_Mapman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C:\Users\Salt%20VII\Dropbox\Caracterizaci&#243;n_funcional_RNA_helicase_339\Microarray_339_Mayo'15\Listas_genes_FC1,5_FC2_pv0.05_conosinFDR\MapMan\Grafica_number_genes_Mapma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8980253110337517"/>
          <c:y val="1.9554327747175023E-2"/>
          <c:w val="0.75783010994593414"/>
          <c:h val="0.91358145805544799"/>
        </c:manualLayout>
      </c:layout>
      <c:barChart>
        <c:barDir val="bar"/>
        <c:grouping val="clustered"/>
        <c:varyColors val="0"/>
        <c:ser>
          <c:idx val="1"/>
          <c:order val="0"/>
          <c:tx>
            <c:v>res</c:v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339R-WTR'!$B$3:$B$21</c:f>
              <c:strCache>
                <c:ptCount val="19"/>
                <c:pt idx="0">
                  <c:v>Unknown</c:v>
                </c:pt>
                <c:pt idx="1">
                  <c:v>Cell wall processes</c:v>
                </c:pt>
                <c:pt idx="2">
                  <c:v>Transcription factors</c:v>
                </c:pt>
                <c:pt idx="3">
                  <c:v>Protein metabolism</c:v>
                </c:pt>
                <c:pt idx="4">
                  <c:v>Signalling</c:v>
                </c:pt>
                <c:pt idx="5">
                  <c:v>Stress-related proteins</c:v>
                </c:pt>
                <c:pt idx="6">
                  <c:v>Transport</c:v>
                </c:pt>
                <c:pt idx="7">
                  <c:v>Hormone metabolism</c:v>
                </c:pt>
                <c:pt idx="8">
                  <c:v>Development</c:v>
                </c:pt>
                <c:pt idx="9">
                  <c:v>Secondary metabolism</c:v>
                </c:pt>
                <c:pt idx="10">
                  <c:v>Lipid metabolism</c:v>
                </c:pt>
                <c:pt idx="11">
                  <c:v>Aminoacid metabolism</c:v>
                </c:pt>
                <c:pt idx="12">
                  <c:v>Cell organisation/division</c:v>
                </c:pt>
                <c:pt idx="13">
                  <c:v>Carbohydrate metabolism</c:v>
                </c:pt>
                <c:pt idx="14">
                  <c:v>RNA metabolism</c:v>
                </c:pt>
                <c:pt idx="15">
                  <c:v>DNA metabolism</c:v>
                </c:pt>
                <c:pt idx="16">
                  <c:v>Redox</c:v>
                </c:pt>
                <c:pt idx="17">
                  <c:v>Nucleotide metabolism</c:v>
                </c:pt>
                <c:pt idx="18">
                  <c:v>TCA</c:v>
                </c:pt>
              </c:strCache>
            </c:strRef>
          </c:cat>
          <c:val>
            <c:numRef>
              <c:f>'339R-WTR'!$C$3:$C$21</c:f>
              <c:numCache>
                <c:formatCode>General</c:formatCode>
                <c:ptCount val="19"/>
                <c:pt idx="0">
                  <c:v>295</c:v>
                </c:pt>
                <c:pt idx="1">
                  <c:v>153</c:v>
                </c:pt>
                <c:pt idx="2">
                  <c:v>147</c:v>
                </c:pt>
                <c:pt idx="3">
                  <c:v>138</c:v>
                </c:pt>
                <c:pt idx="4">
                  <c:v>118</c:v>
                </c:pt>
                <c:pt idx="5">
                  <c:v>100</c:v>
                </c:pt>
                <c:pt idx="6">
                  <c:v>97</c:v>
                </c:pt>
                <c:pt idx="7">
                  <c:v>76</c:v>
                </c:pt>
                <c:pt idx="8">
                  <c:v>52</c:v>
                </c:pt>
                <c:pt idx="9">
                  <c:v>48</c:v>
                </c:pt>
                <c:pt idx="10">
                  <c:v>41</c:v>
                </c:pt>
                <c:pt idx="11">
                  <c:v>27</c:v>
                </c:pt>
                <c:pt idx="12">
                  <c:v>27</c:v>
                </c:pt>
                <c:pt idx="13">
                  <c:v>16</c:v>
                </c:pt>
                <c:pt idx="14">
                  <c:v>10</c:v>
                </c:pt>
                <c:pt idx="15">
                  <c:v>7</c:v>
                </c:pt>
                <c:pt idx="16">
                  <c:v>6</c:v>
                </c:pt>
                <c:pt idx="17">
                  <c:v>5</c:v>
                </c:pt>
                <c:pt idx="18">
                  <c:v>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1AF-4EB9-A25C-8FB91D08D749}"/>
            </c:ext>
          </c:extLst>
        </c:ser>
        <c:ser>
          <c:idx val="0"/>
          <c:order val="1"/>
          <c:tx>
            <c:v>WT</c:v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339R-WTR'!$B$3:$B$21</c:f>
              <c:strCache>
                <c:ptCount val="19"/>
                <c:pt idx="0">
                  <c:v>Unknown</c:v>
                </c:pt>
                <c:pt idx="1">
                  <c:v>Cell wall processes</c:v>
                </c:pt>
                <c:pt idx="2">
                  <c:v>Transcription factors</c:v>
                </c:pt>
                <c:pt idx="3">
                  <c:v>Protein metabolism</c:v>
                </c:pt>
                <c:pt idx="4">
                  <c:v>Signalling</c:v>
                </c:pt>
                <c:pt idx="5">
                  <c:v>Stress-related proteins</c:v>
                </c:pt>
                <c:pt idx="6">
                  <c:v>Transport</c:v>
                </c:pt>
                <c:pt idx="7">
                  <c:v>Hormone metabolism</c:v>
                </c:pt>
                <c:pt idx="8">
                  <c:v>Development</c:v>
                </c:pt>
                <c:pt idx="9">
                  <c:v>Secondary metabolism</c:v>
                </c:pt>
                <c:pt idx="10">
                  <c:v>Lipid metabolism</c:v>
                </c:pt>
                <c:pt idx="11">
                  <c:v>Aminoacid metabolism</c:v>
                </c:pt>
                <c:pt idx="12">
                  <c:v>Cell organisation/division</c:v>
                </c:pt>
                <c:pt idx="13">
                  <c:v>Carbohydrate metabolism</c:v>
                </c:pt>
                <c:pt idx="14">
                  <c:v>RNA metabolism</c:v>
                </c:pt>
                <c:pt idx="15">
                  <c:v>DNA metabolism</c:v>
                </c:pt>
                <c:pt idx="16">
                  <c:v>Redox</c:v>
                </c:pt>
                <c:pt idx="17">
                  <c:v>Nucleotide metabolism</c:v>
                </c:pt>
                <c:pt idx="18">
                  <c:v>TCA</c:v>
                </c:pt>
              </c:strCache>
            </c:strRef>
          </c:cat>
          <c:val>
            <c:numRef>
              <c:f>'339R-WTR'!$F$3:$F$21</c:f>
              <c:numCache>
                <c:formatCode>General</c:formatCode>
                <c:ptCount val="19"/>
                <c:pt idx="0">
                  <c:v>54</c:v>
                </c:pt>
                <c:pt idx="1">
                  <c:v>24</c:v>
                </c:pt>
                <c:pt idx="2">
                  <c:v>27</c:v>
                </c:pt>
                <c:pt idx="3">
                  <c:v>33</c:v>
                </c:pt>
                <c:pt idx="4">
                  <c:v>18</c:v>
                </c:pt>
                <c:pt idx="5">
                  <c:v>25</c:v>
                </c:pt>
                <c:pt idx="6">
                  <c:v>46</c:v>
                </c:pt>
                <c:pt idx="7">
                  <c:v>14</c:v>
                </c:pt>
                <c:pt idx="8">
                  <c:v>12</c:v>
                </c:pt>
                <c:pt idx="9">
                  <c:v>14</c:v>
                </c:pt>
                <c:pt idx="10">
                  <c:v>15</c:v>
                </c:pt>
                <c:pt idx="11">
                  <c:v>10</c:v>
                </c:pt>
                <c:pt idx="12">
                  <c:v>4</c:v>
                </c:pt>
                <c:pt idx="13">
                  <c:v>9</c:v>
                </c:pt>
                <c:pt idx="14">
                  <c:v>3</c:v>
                </c:pt>
                <c:pt idx="15">
                  <c:v>7</c:v>
                </c:pt>
                <c:pt idx="16">
                  <c:v>3</c:v>
                </c:pt>
                <c:pt idx="17">
                  <c:v>1</c:v>
                </c:pt>
                <c:pt idx="18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1AF-4EB9-A25C-8FB91D08D7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16030464"/>
        <c:axId val="139023104"/>
      </c:barChart>
      <c:catAx>
        <c:axId val="1160304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139023104"/>
        <c:crosses val="autoZero"/>
        <c:auto val="1"/>
        <c:lblAlgn val="ctr"/>
        <c:lblOffset val="100"/>
        <c:noMultiLvlLbl val="0"/>
      </c:catAx>
      <c:valAx>
        <c:axId val="139023104"/>
        <c:scaling>
          <c:orientation val="minMax"/>
          <c:max val="500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116030464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legend>
      <c:legendPos val="r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</c:legendEntry>
      <c:layout>
        <c:manualLayout>
          <c:xMode val="edge"/>
          <c:yMode val="edge"/>
          <c:x val="0.65819750994351001"/>
          <c:y val="6.1332490472031535E-2"/>
          <c:w val="0.11015758087710301"/>
          <c:h val="0.1095563115476509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/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490124218343675"/>
          <c:y val="9.773245557420077E-3"/>
          <c:w val="0.83190375396623806"/>
          <c:h val="0.88365282839448167"/>
        </c:manualLayout>
      </c:layout>
      <c:barChart>
        <c:barDir val="bar"/>
        <c:grouping val="clustered"/>
        <c:varyColors val="0"/>
        <c:ser>
          <c:idx val="1"/>
          <c:order val="0"/>
          <c:tx>
            <c:v>res</c:v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339H-WTH'!$B$3:$B$23</c:f>
              <c:strCache>
                <c:ptCount val="21"/>
                <c:pt idx="0">
                  <c:v>Unknown</c:v>
                </c:pt>
                <c:pt idx="1">
                  <c:v>Protein metabolism</c:v>
                </c:pt>
                <c:pt idx="2">
                  <c:v>Transcription factors</c:v>
                </c:pt>
                <c:pt idx="3">
                  <c:v>Signalling</c:v>
                </c:pt>
                <c:pt idx="4">
                  <c:v>Transport</c:v>
                </c:pt>
                <c:pt idx="5">
                  <c:v>Stress-related proteins</c:v>
                </c:pt>
                <c:pt idx="6">
                  <c:v>Cell wall processes</c:v>
                </c:pt>
                <c:pt idx="7">
                  <c:v>Lipid metabolism</c:v>
                </c:pt>
                <c:pt idx="8">
                  <c:v>Development</c:v>
                </c:pt>
                <c:pt idx="9">
                  <c:v>Secondary metabolism</c:v>
                </c:pt>
                <c:pt idx="10">
                  <c:v>Hormone metabolism</c:v>
                </c:pt>
                <c:pt idx="11">
                  <c:v>Aminoacid metabolism</c:v>
                </c:pt>
                <c:pt idx="12">
                  <c:v>Cell organisation/division</c:v>
                </c:pt>
                <c:pt idx="13">
                  <c:v>Photosynthesis</c:v>
                </c:pt>
                <c:pt idx="14">
                  <c:v>DNA metabolism</c:v>
                </c:pt>
                <c:pt idx="15">
                  <c:v>RNA metabolism</c:v>
                </c:pt>
                <c:pt idx="16">
                  <c:v>Carbohydrate metabolism</c:v>
                </c:pt>
                <c:pt idx="17">
                  <c:v>Redox</c:v>
                </c:pt>
                <c:pt idx="18">
                  <c:v>Nucleotide metabolism</c:v>
                </c:pt>
                <c:pt idx="19">
                  <c:v>Glycolysis</c:v>
                </c:pt>
                <c:pt idx="20">
                  <c:v>TCA</c:v>
                </c:pt>
              </c:strCache>
            </c:strRef>
          </c:cat>
          <c:val>
            <c:numRef>
              <c:f>'339H-WTH'!$C$3:$C$23</c:f>
              <c:numCache>
                <c:formatCode>General</c:formatCode>
                <c:ptCount val="21"/>
                <c:pt idx="0">
                  <c:v>294</c:v>
                </c:pt>
                <c:pt idx="1">
                  <c:v>243</c:v>
                </c:pt>
                <c:pt idx="2">
                  <c:v>153</c:v>
                </c:pt>
                <c:pt idx="3">
                  <c:v>150</c:v>
                </c:pt>
                <c:pt idx="4">
                  <c:v>103</c:v>
                </c:pt>
                <c:pt idx="5">
                  <c:v>86</c:v>
                </c:pt>
                <c:pt idx="6">
                  <c:v>67</c:v>
                </c:pt>
                <c:pt idx="7">
                  <c:v>65</c:v>
                </c:pt>
                <c:pt idx="8">
                  <c:v>63</c:v>
                </c:pt>
                <c:pt idx="9">
                  <c:v>53</c:v>
                </c:pt>
                <c:pt idx="10">
                  <c:v>50</c:v>
                </c:pt>
                <c:pt idx="11">
                  <c:v>44</c:v>
                </c:pt>
                <c:pt idx="12">
                  <c:v>37</c:v>
                </c:pt>
                <c:pt idx="13">
                  <c:v>31</c:v>
                </c:pt>
                <c:pt idx="14">
                  <c:v>30</c:v>
                </c:pt>
                <c:pt idx="15">
                  <c:v>23</c:v>
                </c:pt>
                <c:pt idx="16">
                  <c:v>22</c:v>
                </c:pt>
                <c:pt idx="17">
                  <c:v>19</c:v>
                </c:pt>
                <c:pt idx="18">
                  <c:v>15</c:v>
                </c:pt>
                <c:pt idx="19">
                  <c:v>7</c:v>
                </c:pt>
                <c:pt idx="20">
                  <c:v>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C31-407C-80D2-D39884A554E7}"/>
            </c:ext>
          </c:extLst>
        </c:ser>
        <c:ser>
          <c:idx val="0"/>
          <c:order val="1"/>
          <c:tx>
            <c:v>WT</c:v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339H-WTH'!$B$3:$B$23</c:f>
              <c:strCache>
                <c:ptCount val="21"/>
                <c:pt idx="0">
                  <c:v>Unknown</c:v>
                </c:pt>
                <c:pt idx="1">
                  <c:v>Protein metabolism</c:v>
                </c:pt>
                <c:pt idx="2">
                  <c:v>Transcription factors</c:v>
                </c:pt>
                <c:pt idx="3">
                  <c:v>Signalling</c:v>
                </c:pt>
                <c:pt idx="4">
                  <c:v>Transport</c:v>
                </c:pt>
                <c:pt idx="5">
                  <c:v>Stress-related proteins</c:v>
                </c:pt>
                <c:pt idx="6">
                  <c:v>Cell wall processes</c:v>
                </c:pt>
                <c:pt idx="7">
                  <c:v>Lipid metabolism</c:v>
                </c:pt>
                <c:pt idx="8">
                  <c:v>Development</c:v>
                </c:pt>
                <c:pt idx="9">
                  <c:v>Secondary metabolism</c:v>
                </c:pt>
                <c:pt idx="10">
                  <c:v>Hormone metabolism</c:v>
                </c:pt>
                <c:pt idx="11">
                  <c:v>Aminoacid metabolism</c:v>
                </c:pt>
                <c:pt idx="12">
                  <c:v>Cell organisation/division</c:v>
                </c:pt>
                <c:pt idx="13">
                  <c:v>Photosynthesis</c:v>
                </c:pt>
                <c:pt idx="14">
                  <c:v>DNA metabolism</c:v>
                </c:pt>
                <c:pt idx="15">
                  <c:v>RNA metabolism</c:v>
                </c:pt>
                <c:pt idx="16">
                  <c:v>Carbohydrate metabolism</c:v>
                </c:pt>
                <c:pt idx="17">
                  <c:v>Redox</c:v>
                </c:pt>
                <c:pt idx="18">
                  <c:v>Nucleotide metabolism</c:v>
                </c:pt>
                <c:pt idx="19">
                  <c:v>Glycolysis</c:v>
                </c:pt>
                <c:pt idx="20">
                  <c:v>TCA</c:v>
                </c:pt>
              </c:strCache>
            </c:strRef>
          </c:cat>
          <c:val>
            <c:numRef>
              <c:f>'339H-WTH'!$F$3:$F$23</c:f>
              <c:numCache>
                <c:formatCode>General</c:formatCode>
                <c:ptCount val="21"/>
                <c:pt idx="0">
                  <c:v>432</c:v>
                </c:pt>
                <c:pt idx="1">
                  <c:v>291</c:v>
                </c:pt>
                <c:pt idx="2">
                  <c:v>245</c:v>
                </c:pt>
                <c:pt idx="3">
                  <c:v>140</c:v>
                </c:pt>
                <c:pt idx="4">
                  <c:v>151</c:v>
                </c:pt>
                <c:pt idx="5">
                  <c:v>95</c:v>
                </c:pt>
                <c:pt idx="6">
                  <c:v>66</c:v>
                </c:pt>
                <c:pt idx="7">
                  <c:v>64</c:v>
                </c:pt>
                <c:pt idx="8">
                  <c:v>82</c:v>
                </c:pt>
                <c:pt idx="9">
                  <c:v>47</c:v>
                </c:pt>
                <c:pt idx="10">
                  <c:v>68</c:v>
                </c:pt>
                <c:pt idx="11">
                  <c:v>50</c:v>
                </c:pt>
                <c:pt idx="12">
                  <c:v>75</c:v>
                </c:pt>
                <c:pt idx="13">
                  <c:v>48</c:v>
                </c:pt>
                <c:pt idx="14">
                  <c:v>52</c:v>
                </c:pt>
                <c:pt idx="15">
                  <c:v>59</c:v>
                </c:pt>
                <c:pt idx="16">
                  <c:v>40</c:v>
                </c:pt>
                <c:pt idx="17">
                  <c:v>29</c:v>
                </c:pt>
                <c:pt idx="18">
                  <c:v>27</c:v>
                </c:pt>
                <c:pt idx="19">
                  <c:v>11</c:v>
                </c:pt>
                <c:pt idx="20">
                  <c:v>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C31-407C-80D2-D39884A554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133272320"/>
        <c:axId val="133273856"/>
      </c:barChart>
      <c:catAx>
        <c:axId val="13327232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133273856"/>
        <c:crosses val="autoZero"/>
        <c:auto val="1"/>
        <c:lblAlgn val="ctr"/>
        <c:lblOffset val="100"/>
        <c:noMultiLvlLbl val="0"/>
      </c:catAx>
      <c:valAx>
        <c:axId val="133273856"/>
        <c:scaling>
          <c:orientation val="minMax"/>
          <c:max val="500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  <c:crossAx val="1332723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s-ES"/>
          </a:p>
        </c:txPr>
      </c:legendEntry>
      <c:layout>
        <c:manualLayout>
          <c:xMode val="edge"/>
          <c:yMode val="edge"/>
          <c:x val="0.69060870264780116"/>
          <c:y val="9.166614173228349E-2"/>
          <c:w val="0.11015758087710301"/>
          <c:h val="0.115075096547091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71800" cy="496888"/>
          </a:xfrm>
          <a:prstGeom prst="rect">
            <a:avLst/>
          </a:prstGeom>
        </p:spPr>
        <p:txBody>
          <a:bodyPr vert="horz" lIns="91392" tIns="45698" rIns="91392" bIns="45698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7" y="0"/>
            <a:ext cx="2971800" cy="496888"/>
          </a:xfrm>
          <a:prstGeom prst="rect">
            <a:avLst/>
          </a:prstGeom>
        </p:spPr>
        <p:txBody>
          <a:bodyPr vert="horz" lIns="91392" tIns="45698" rIns="91392" bIns="45698" rtlCol="0"/>
          <a:lstStyle>
            <a:lvl1pPr algn="r">
              <a:defRPr sz="1200"/>
            </a:lvl1pPr>
          </a:lstStyle>
          <a:p>
            <a:fld id="{72B78F72-AAAC-42DC-B26A-88E113706900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6125"/>
            <a:ext cx="2638425" cy="3730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92" tIns="45698" rIns="91392" bIns="45698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1" y="4724401"/>
            <a:ext cx="5486400" cy="4476750"/>
          </a:xfrm>
          <a:prstGeom prst="rect">
            <a:avLst/>
          </a:prstGeom>
        </p:spPr>
        <p:txBody>
          <a:bodyPr vert="horz" lIns="91392" tIns="45698" rIns="91392" bIns="45698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1" y="9448801"/>
            <a:ext cx="2971800" cy="496888"/>
          </a:xfrm>
          <a:prstGeom prst="rect">
            <a:avLst/>
          </a:prstGeom>
        </p:spPr>
        <p:txBody>
          <a:bodyPr vert="horz" lIns="91392" tIns="45698" rIns="91392" bIns="45698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7" y="9448801"/>
            <a:ext cx="2971800" cy="496888"/>
          </a:xfrm>
          <a:prstGeom prst="rect">
            <a:avLst/>
          </a:prstGeom>
        </p:spPr>
        <p:txBody>
          <a:bodyPr vert="horz" lIns="91392" tIns="45698" rIns="91392" bIns="45698" rtlCol="0" anchor="b"/>
          <a:lstStyle>
            <a:lvl1pPr algn="r">
              <a:defRPr sz="1200"/>
            </a:lvl1pPr>
          </a:lstStyle>
          <a:p>
            <a:fld id="{42FA20B8-F23D-46C9-91F7-0683655A117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60072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66976" y="3321395"/>
            <a:ext cx="6425724" cy="2291810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133951" y="6058694"/>
            <a:ext cx="5291773" cy="273235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5464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42040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110573" y="571716"/>
            <a:ext cx="1275696" cy="1216193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83489" y="571716"/>
            <a:ext cx="3701091" cy="1216193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03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2109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97162" y="6870480"/>
            <a:ext cx="6425724" cy="21235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97162" y="4531650"/>
            <a:ext cx="6425724" cy="233883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2675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83489" y="3326343"/>
            <a:ext cx="2488393" cy="940731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897877" y="3326343"/>
            <a:ext cx="2488393" cy="940731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6055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77984" y="428168"/>
            <a:ext cx="6803708" cy="1781969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77986" y="2393283"/>
            <a:ext cx="3340169" cy="9974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77986" y="3390690"/>
            <a:ext cx="3340169" cy="61601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840212" y="2393283"/>
            <a:ext cx="3341481" cy="99740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840212" y="3390690"/>
            <a:ext cx="3341481" cy="61601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06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2344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1292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77986" y="425693"/>
            <a:ext cx="2487081" cy="181166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955624" y="425696"/>
            <a:ext cx="4226069" cy="9125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77986" y="2237363"/>
            <a:ext cx="2487081" cy="731349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23091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481749" y="7484271"/>
            <a:ext cx="4535805" cy="88356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481749" y="955333"/>
            <a:ext cx="4535805" cy="641508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481749" y="8367832"/>
            <a:ext cx="4535805" cy="125480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4026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77984" y="428168"/>
            <a:ext cx="6803708" cy="17819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77984" y="2494759"/>
            <a:ext cx="6803708" cy="70561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77984" y="9909730"/>
            <a:ext cx="176392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8BCF9-E7DC-43B9-A9CA-D269F2D89CCB}" type="datetimeFigureOut">
              <a:rPr lang="es-ES" smtClean="0"/>
              <a:t>04/07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582889" y="9909730"/>
            <a:ext cx="239389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5417767" y="9909730"/>
            <a:ext cx="176392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F7F60D-D6D3-4846-9309-815741290AF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5078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Gráfico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0205468"/>
              </p:ext>
            </p:extLst>
          </p:nvPr>
        </p:nvGraphicFramePr>
        <p:xfrm>
          <a:off x="852477" y="3082066"/>
          <a:ext cx="3134708" cy="25700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9" name="Gráfico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276875"/>
              </p:ext>
            </p:extLst>
          </p:nvPr>
        </p:nvGraphicFramePr>
        <p:xfrm>
          <a:off x="3828086" y="3089861"/>
          <a:ext cx="3099954" cy="25453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62" name="Grupo 61"/>
          <p:cNvGrpSpPr/>
          <p:nvPr/>
        </p:nvGrpSpPr>
        <p:grpSpPr>
          <a:xfrm>
            <a:off x="1043533" y="1036921"/>
            <a:ext cx="5745418" cy="1456600"/>
            <a:chOff x="647248" y="82347"/>
            <a:chExt cx="5745418" cy="1456600"/>
          </a:xfrm>
        </p:grpSpPr>
        <p:grpSp>
          <p:nvGrpSpPr>
            <p:cNvPr id="54" name="Grupo 53"/>
            <p:cNvGrpSpPr/>
            <p:nvPr/>
          </p:nvGrpSpPr>
          <p:grpSpPr>
            <a:xfrm>
              <a:off x="4005064" y="289702"/>
              <a:ext cx="1744712" cy="1224136"/>
              <a:chOff x="-3321854" y="2168459"/>
              <a:chExt cx="1744712" cy="1224136"/>
            </a:xfrm>
          </p:grpSpPr>
          <p:grpSp>
            <p:nvGrpSpPr>
              <p:cNvPr id="46" name="Grupo 45"/>
              <p:cNvGrpSpPr/>
              <p:nvPr/>
            </p:nvGrpSpPr>
            <p:grpSpPr>
              <a:xfrm>
                <a:off x="-3321854" y="2168459"/>
                <a:ext cx="1735124" cy="1224136"/>
                <a:chOff x="-3321854" y="2168459"/>
                <a:chExt cx="1735124" cy="1224136"/>
              </a:xfrm>
            </p:grpSpPr>
            <p:sp>
              <p:nvSpPr>
                <p:cNvPr id="42" name="86 Elipse"/>
                <p:cNvSpPr/>
                <p:nvPr/>
              </p:nvSpPr>
              <p:spPr>
                <a:xfrm>
                  <a:off x="-3321854" y="2168459"/>
                  <a:ext cx="1261735" cy="1224136"/>
                </a:xfrm>
                <a:prstGeom prst="ellipse">
                  <a:avLst/>
                </a:prstGeom>
                <a:solidFill>
                  <a:schemeClr val="accent4">
                    <a:lumMod val="75000"/>
                    <a:alpha val="50000"/>
                  </a:schemeClr>
                </a:solidFill>
                <a:ln w="285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86 Elipse"/>
                <p:cNvSpPr/>
                <p:nvPr/>
              </p:nvSpPr>
              <p:spPr>
                <a:xfrm>
                  <a:off x="-2659603" y="2272677"/>
                  <a:ext cx="1072873" cy="1029653"/>
                </a:xfrm>
                <a:prstGeom prst="ellipse">
                  <a:avLst/>
                </a:prstGeom>
                <a:solidFill>
                  <a:schemeClr val="accent6">
                    <a:lumMod val="75000"/>
                    <a:alpha val="50000"/>
                  </a:schemeClr>
                </a:solidFill>
                <a:ln w="285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8" name="93 CuadroTexto"/>
              <p:cNvSpPr txBox="1"/>
              <p:nvPr/>
            </p:nvSpPr>
            <p:spPr>
              <a:xfrm>
                <a:off x="-3152596" y="2649993"/>
                <a:ext cx="49533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964</a:t>
                </a:r>
              </a:p>
            </p:txBody>
          </p:sp>
          <p:sp>
            <p:nvSpPr>
              <p:cNvPr id="49" name="93 CuadroTexto"/>
              <p:cNvSpPr txBox="1"/>
              <p:nvPr/>
            </p:nvSpPr>
            <p:spPr>
              <a:xfrm>
                <a:off x="-2551168" y="2649722"/>
                <a:ext cx="49533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29</a:t>
                </a:r>
              </a:p>
            </p:txBody>
          </p:sp>
          <p:sp>
            <p:nvSpPr>
              <p:cNvPr id="50" name="93 CuadroTexto"/>
              <p:cNvSpPr txBox="1"/>
              <p:nvPr/>
            </p:nvSpPr>
            <p:spPr>
              <a:xfrm>
                <a:off x="-2072476" y="2656699"/>
                <a:ext cx="49533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40</a:t>
                </a:r>
              </a:p>
            </p:txBody>
          </p:sp>
        </p:grpSp>
        <p:grpSp>
          <p:nvGrpSpPr>
            <p:cNvPr id="55" name="Grupo 54"/>
            <p:cNvGrpSpPr/>
            <p:nvPr/>
          </p:nvGrpSpPr>
          <p:grpSpPr>
            <a:xfrm>
              <a:off x="1056736" y="455883"/>
              <a:ext cx="1323409" cy="901611"/>
              <a:chOff x="-2723861" y="3635268"/>
              <a:chExt cx="1323409" cy="901611"/>
            </a:xfrm>
          </p:grpSpPr>
          <p:grpSp>
            <p:nvGrpSpPr>
              <p:cNvPr id="47" name="Grupo 46"/>
              <p:cNvGrpSpPr/>
              <p:nvPr/>
            </p:nvGrpSpPr>
            <p:grpSpPr>
              <a:xfrm>
                <a:off x="-2714650" y="3635268"/>
                <a:ext cx="1314198" cy="901611"/>
                <a:chOff x="-2745733" y="3647393"/>
                <a:chExt cx="1314198" cy="901611"/>
              </a:xfrm>
            </p:grpSpPr>
            <p:sp>
              <p:nvSpPr>
                <p:cNvPr id="44" name="86 Elipse"/>
                <p:cNvSpPr/>
                <p:nvPr/>
              </p:nvSpPr>
              <p:spPr>
                <a:xfrm>
                  <a:off x="-2374886" y="3647393"/>
                  <a:ext cx="943351" cy="901611"/>
                </a:xfrm>
                <a:prstGeom prst="ellipse">
                  <a:avLst/>
                </a:prstGeom>
                <a:solidFill>
                  <a:schemeClr val="accent6">
                    <a:lumMod val="75000"/>
                    <a:alpha val="50000"/>
                  </a:schemeClr>
                </a:solidFill>
                <a:ln w="285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" name="85 Elipse"/>
                <p:cNvSpPr/>
                <p:nvPr/>
              </p:nvSpPr>
              <p:spPr>
                <a:xfrm>
                  <a:off x="-2745733" y="3779911"/>
                  <a:ext cx="647535" cy="637830"/>
                </a:xfrm>
                <a:prstGeom prst="ellipse">
                  <a:avLst/>
                </a:prstGeom>
                <a:solidFill>
                  <a:schemeClr val="accent4">
                    <a:lumMod val="75000"/>
                    <a:alpha val="50000"/>
                  </a:schemeClr>
                </a:solidFill>
                <a:ln w="2857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4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51" name="93 CuadroTexto"/>
              <p:cNvSpPr txBox="1"/>
              <p:nvPr/>
            </p:nvSpPr>
            <p:spPr>
              <a:xfrm>
                <a:off x="-2723861" y="3943644"/>
                <a:ext cx="49533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0</a:t>
                </a:r>
              </a:p>
            </p:txBody>
          </p:sp>
          <p:sp>
            <p:nvSpPr>
              <p:cNvPr id="52" name="93 CuadroTexto"/>
              <p:cNvSpPr txBox="1"/>
              <p:nvPr/>
            </p:nvSpPr>
            <p:spPr>
              <a:xfrm>
                <a:off x="-2409954" y="3943644"/>
                <a:ext cx="49533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8</a:t>
                </a:r>
              </a:p>
            </p:txBody>
          </p:sp>
          <p:sp>
            <p:nvSpPr>
              <p:cNvPr id="53" name="93 CuadroTexto"/>
              <p:cNvSpPr txBox="1"/>
              <p:nvPr/>
            </p:nvSpPr>
            <p:spPr>
              <a:xfrm>
                <a:off x="-2010086" y="3943644"/>
                <a:ext cx="49533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38</a:t>
                </a:r>
              </a:p>
            </p:txBody>
          </p:sp>
        </p:grpSp>
        <p:sp>
          <p:nvSpPr>
            <p:cNvPr id="56" name="91 CuadroTexto"/>
            <p:cNvSpPr txBox="1"/>
            <p:nvPr/>
          </p:nvSpPr>
          <p:spPr>
            <a:xfrm>
              <a:off x="647248" y="1108060"/>
              <a:ext cx="63231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>
                  <a:solidFill>
                    <a:schemeClr val="accent4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  <a:p>
              <a:pPr algn="ctr"/>
              <a:r>
                <a:rPr lang="es-ES" sz="1100" b="1" dirty="0">
                  <a:solidFill>
                    <a:schemeClr val="accent4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428)</a:t>
              </a:r>
            </a:p>
          </p:txBody>
        </p:sp>
        <p:sp>
          <p:nvSpPr>
            <p:cNvPr id="57" name="92 CuadroTexto"/>
            <p:cNvSpPr txBox="1"/>
            <p:nvPr/>
          </p:nvSpPr>
          <p:spPr>
            <a:xfrm>
              <a:off x="1957863" y="1108060"/>
              <a:ext cx="98151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i="1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s</a:t>
              </a:r>
            </a:p>
            <a:p>
              <a:pPr algn="ctr"/>
              <a:r>
                <a:rPr lang="es-ES" sz="1100" b="1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1726)</a:t>
              </a:r>
            </a:p>
          </p:txBody>
        </p:sp>
        <p:sp>
          <p:nvSpPr>
            <p:cNvPr id="58" name="91 CuadroTexto"/>
            <p:cNvSpPr txBox="1"/>
            <p:nvPr/>
          </p:nvSpPr>
          <p:spPr>
            <a:xfrm>
              <a:off x="3532785" y="1108060"/>
              <a:ext cx="63231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>
                  <a:solidFill>
                    <a:schemeClr val="accent4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  <a:p>
              <a:pPr algn="ctr"/>
              <a:r>
                <a:rPr lang="es-ES" sz="1100" b="1" dirty="0">
                  <a:solidFill>
                    <a:schemeClr val="accent4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2793)</a:t>
              </a:r>
            </a:p>
          </p:txBody>
        </p:sp>
        <p:sp>
          <p:nvSpPr>
            <p:cNvPr id="59" name="92 CuadroTexto"/>
            <p:cNvSpPr txBox="1"/>
            <p:nvPr/>
          </p:nvSpPr>
          <p:spPr>
            <a:xfrm>
              <a:off x="5411148" y="1108060"/>
              <a:ext cx="98151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i="1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s</a:t>
              </a:r>
            </a:p>
            <a:p>
              <a:pPr algn="ctr"/>
              <a:r>
                <a:rPr lang="es-ES" sz="1100" b="1" dirty="0">
                  <a:solidFill>
                    <a:schemeClr val="accent6">
                      <a:lumMod val="7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2169)</a:t>
              </a:r>
            </a:p>
          </p:txBody>
        </p:sp>
        <p:sp>
          <p:nvSpPr>
            <p:cNvPr id="60" name="90 CuadroTexto"/>
            <p:cNvSpPr txBox="1"/>
            <p:nvPr/>
          </p:nvSpPr>
          <p:spPr>
            <a:xfrm>
              <a:off x="1403417" y="148594"/>
              <a:ext cx="6809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OT</a:t>
              </a:r>
            </a:p>
          </p:txBody>
        </p:sp>
        <p:sp>
          <p:nvSpPr>
            <p:cNvPr id="61" name="75 CuadroTexto"/>
            <p:cNvSpPr txBox="1"/>
            <p:nvPr/>
          </p:nvSpPr>
          <p:spPr>
            <a:xfrm>
              <a:off x="4811967" y="82347"/>
              <a:ext cx="5991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AF</a:t>
              </a:r>
            </a:p>
          </p:txBody>
        </p:sp>
      </p:grpSp>
      <p:sp>
        <p:nvSpPr>
          <p:cNvPr id="32" name="92 CuadroTexto"/>
          <p:cNvSpPr txBox="1"/>
          <p:nvPr/>
        </p:nvSpPr>
        <p:spPr>
          <a:xfrm>
            <a:off x="1441761" y="5660360"/>
            <a:ext cx="2736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es-E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genes</a:t>
            </a:r>
          </a:p>
        </p:txBody>
      </p:sp>
      <p:sp>
        <p:nvSpPr>
          <p:cNvPr id="33" name="92 CuadroTexto"/>
          <p:cNvSpPr txBox="1"/>
          <p:nvPr/>
        </p:nvSpPr>
        <p:spPr>
          <a:xfrm>
            <a:off x="4421664" y="5660360"/>
            <a:ext cx="27363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es-E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genes</a:t>
            </a:r>
          </a:p>
        </p:txBody>
      </p:sp>
      <p:sp>
        <p:nvSpPr>
          <p:cNvPr id="34" name="8 CuadroTexto"/>
          <p:cNvSpPr txBox="1"/>
          <p:nvPr/>
        </p:nvSpPr>
        <p:spPr>
          <a:xfrm>
            <a:off x="683493" y="953418"/>
            <a:ext cx="3931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s-ES" sz="1600" b="1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8 CuadroTexto"/>
          <p:cNvSpPr txBox="1"/>
          <p:nvPr/>
        </p:nvSpPr>
        <p:spPr>
          <a:xfrm>
            <a:off x="682429" y="2753618"/>
            <a:ext cx="3931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s-ES" sz="1600" b="1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4 CuadroTexto"/>
          <p:cNvSpPr txBox="1"/>
          <p:nvPr/>
        </p:nvSpPr>
        <p:spPr>
          <a:xfrm>
            <a:off x="323453" y="214000"/>
            <a:ext cx="63367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746118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42</TotalTime>
  <Words>36</Words>
  <Application>Microsoft Office PowerPoint</Application>
  <PresentationFormat>Personalizado</PresentationFormat>
  <Paragraphs>2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loma Sánchez Bel</dc:creator>
  <cp:lastModifiedBy>Irene</cp:lastModifiedBy>
  <cp:revision>497</cp:revision>
  <cp:lastPrinted>2017-10-24T16:42:37Z</cp:lastPrinted>
  <dcterms:created xsi:type="dcterms:W3CDTF">2016-11-10T12:20:59Z</dcterms:created>
  <dcterms:modified xsi:type="dcterms:W3CDTF">2018-07-04T17:42:43Z</dcterms:modified>
</cp:coreProperties>
</file>